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4"/>
  </p:notesMasterIdLst>
  <p:sldIdLst>
    <p:sldId id="261" r:id="rId2"/>
    <p:sldId id="262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606"/>
    <p:restoredTop sz="95101"/>
  </p:normalViewPr>
  <p:slideViewPr>
    <p:cSldViewPr snapToGrid="0">
      <p:cViewPr>
        <p:scale>
          <a:sx n="141" d="100"/>
          <a:sy n="141" d="100"/>
        </p:scale>
        <p:origin x="2208" y="-37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0C1C668-C4B3-224A-8028-AC5304279C51}" type="datetimeFigureOut">
              <a:rPr lang="de-DE" smtClean="0"/>
              <a:t>21.06.24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0F7402C-FC65-224A-877E-CF5BD0F5D02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367379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B6A880F-E96D-7548-A0DA-7546D018CE5A}" type="slidenum">
              <a:rPr lang="de-DE" smtClean="0"/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4737001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39631A-176F-8F41-94FE-2ED7D9B73D4E}" type="datetimeFigureOut">
              <a:rPr lang="de-DE" smtClean="0"/>
              <a:t>21.06.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273E34-408B-AE42-8208-9398FE31CCE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006857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39631A-176F-8F41-94FE-2ED7D9B73D4E}" type="datetimeFigureOut">
              <a:rPr lang="de-DE" smtClean="0"/>
              <a:t>21.06.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273E34-408B-AE42-8208-9398FE31CCE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019017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39631A-176F-8F41-94FE-2ED7D9B73D4E}" type="datetimeFigureOut">
              <a:rPr lang="de-DE" smtClean="0"/>
              <a:t>21.06.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273E34-408B-AE42-8208-9398FE31CCE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442633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39631A-176F-8F41-94FE-2ED7D9B73D4E}" type="datetimeFigureOut">
              <a:rPr lang="de-DE" smtClean="0"/>
              <a:t>21.06.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273E34-408B-AE42-8208-9398FE31CCE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104212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39631A-176F-8F41-94FE-2ED7D9B73D4E}" type="datetimeFigureOut">
              <a:rPr lang="de-DE" smtClean="0"/>
              <a:t>21.06.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273E34-408B-AE42-8208-9398FE31CCE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693907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39631A-176F-8F41-94FE-2ED7D9B73D4E}" type="datetimeFigureOut">
              <a:rPr lang="de-DE" smtClean="0"/>
              <a:t>21.06.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273E34-408B-AE42-8208-9398FE31CCE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604462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39631A-176F-8F41-94FE-2ED7D9B73D4E}" type="datetimeFigureOut">
              <a:rPr lang="de-DE" smtClean="0"/>
              <a:t>21.06.24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273E34-408B-AE42-8208-9398FE31CCE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640105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39631A-176F-8F41-94FE-2ED7D9B73D4E}" type="datetimeFigureOut">
              <a:rPr lang="de-DE" smtClean="0"/>
              <a:t>21.06.24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273E34-408B-AE42-8208-9398FE31CCE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96451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39631A-176F-8F41-94FE-2ED7D9B73D4E}" type="datetimeFigureOut">
              <a:rPr lang="de-DE" smtClean="0"/>
              <a:t>21.06.24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273E34-408B-AE42-8208-9398FE31CCE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453202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39631A-176F-8F41-94FE-2ED7D9B73D4E}" type="datetimeFigureOut">
              <a:rPr lang="de-DE" smtClean="0"/>
              <a:t>21.06.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273E34-408B-AE42-8208-9398FE31CCE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343525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39631A-176F-8F41-94FE-2ED7D9B73D4E}" type="datetimeFigureOut">
              <a:rPr lang="de-DE" smtClean="0"/>
              <a:t>21.06.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273E34-408B-AE42-8208-9398FE31CCE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101573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39631A-176F-8F41-94FE-2ED7D9B73D4E}" type="datetimeFigureOut">
              <a:rPr lang="de-DE" smtClean="0"/>
              <a:t>21.06.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273E34-408B-AE42-8208-9398FE31CCE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499483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jpg"/><Relationship Id="rId5" Type="http://schemas.openxmlformats.org/officeDocument/2006/relationships/image" Target="../media/image3.jpg"/><Relationship Id="rId4" Type="http://schemas.openxmlformats.org/officeDocument/2006/relationships/image" Target="../media/image2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g"/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9.jpg"/><Relationship Id="rId5" Type="http://schemas.openxmlformats.org/officeDocument/2006/relationships/image" Target="../media/image8.jpg"/><Relationship Id="rId4" Type="http://schemas.openxmlformats.org/officeDocument/2006/relationships/image" Target="../media/image7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feld 4">
            <a:extLst>
              <a:ext uri="{FF2B5EF4-FFF2-40B4-BE49-F238E27FC236}">
                <a16:creationId xmlns:a16="http://schemas.microsoft.com/office/drawing/2014/main" id="{DD1CC38B-1A3C-51E8-2186-AC65029897C2}"/>
              </a:ext>
            </a:extLst>
          </p:cNvPr>
          <p:cNvSpPr txBox="1"/>
          <p:nvPr/>
        </p:nvSpPr>
        <p:spPr>
          <a:xfrm>
            <a:off x="937535" y="926742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18" name="Textfeld 17">
            <a:extLst>
              <a:ext uri="{FF2B5EF4-FFF2-40B4-BE49-F238E27FC236}">
                <a16:creationId xmlns:a16="http://schemas.microsoft.com/office/drawing/2014/main" id="{30EF7281-0DB8-5E17-F03B-1DE6BE43A60B}"/>
              </a:ext>
            </a:extLst>
          </p:cNvPr>
          <p:cNvSpPr txBox="1"/>
          <p:nvPr/>
        </p:nvSpPr>
        <p:spPr>
          <a:xfrm>
            <a:off x="942344" y="3310201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11" name="Textfeld 10">
            <a:extLst>
              <a:ext uri="{FF2B5EF4-FFF2-40B4-BE49-F238E27FC236}">
                <a16:creationId xmlns:a16="http://schemas.microsoft.com/office/drawing/2014/main" id="{0B87A7E6-F8E7-9D77-E5E0-40B732C89E85}"/>
              </a:ext>
            </a:extLst>
          </p:cNvPr>
          <p:cNvSpPr txBox="1"/>
          <p:nvPr/>
        </p:nvSpPr>
        <p:spPr>
          <a:xfrm>
            <a:off x="355649" y="5859610"/>
            <a:ext cx="6067453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8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1: Early response to neocarzinostatin treatment in lymphoblastoid cell lines (LCLs)</a:t>
            </a:r>
            <a:endParaRPr lang="de-AT" sz="105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/>
            <a:r>
              <a:rPr lang="en-US" sz="8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CLs generated from 14 healthy blood donors (HCs; grey bullets), 4 ataxia telangiectasia patients (AT; orange squares), one nijmegen breakage patient (NBS; orange triangle) and three TTD1 patients (TTD-I= red bullets; TTD-II= red squares; TTD-III= red triangle) were treated with neocarzinostatin (500 ng/ml, 1x10</a:t>
            </a:r>
            <a:r>
              <a:rPr lang="en-US" sz="8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6</a:t>
            </a:r>
            <a:r>
              <a:rPr lang="en-US" sz="8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8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ells/ml) for 45 minutes to induce DSBs and incubated for 6 hours recovery in neocarzinostatin-free medium. Symbols show values of each sample and line indicate mean values. (p-value: ns= not significant p &gt; 0.05, *p &lt; 0.05, **p &lt; 0.01, ***p &lt; 0.001, Mann-Whitney test). </a:t>
            </a:r>
            <a:r>
              <a:rPr lang="en-US" sz="8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US" sz="8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800" u="sng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arly DNA damage response.</a:t>
            </a:r>
            <a:r>
              <a:rPr lang="en-US" sz="8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ntracellular </a:t>
            </a:r>
            <a:r>
              <a:rPr lang="en-GB" sz="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  <a:sym typeface="Symbol" pitchFamily="2" charset="2"/>
              </a:rPr>
              <a:t></a:t>
            </a:r>
            <a:r>
              <a:rPr lang="en-US" sz="8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H2AX intensities were measured by multicolor flow cytometry analysis before and after 6 hours recovery. </a:t>
            </a:r>
            <a:r>
              <a:rPr lang="en-US" sz="8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US" sz="8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800" u="sng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poptotic activity.</a:t>
            </a:r>
            <a:r>
              <a:rPr lang="en-US" sz="8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Values represent cleavage of caspase-3 within 6 hours recovery expressed as relative increase compared to non-treated cells.</a:t>
            </a:r>
            <a:r>
              <a:rPr lang="en-US" sz="8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</a:t>
            </a:r>
            <a:r>
              <a:rPr lang="en-US" sz="8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800" u="sng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roliferation of neocarzinostatin treated LCLs.</a:t>
            </a:r>
            <a:r>
              <a:rPr lang="en-US" sz="8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fter DSB induction the cells were incubated in neocarzinostatin free medium in the presence of thymidine-[methyl-3H] for 6 hours recovery. Values represent proliferation expressed as percentage of non-treated cell cultures from the tested individuals.</a:t>
            </a:r>
            <a:endParaRPr lang="de-AT" sz="105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3" name="Grafik 2" descr="Ein Bild, das Text, Screenshot, Diagramm, Reihe enthält.&#10;&#10;Automatisch generierte Beschreibung">
            <a:extLst>
              <a:ext uri="{FF2B5EF4-FFF2-40B4-BE49-F238E27FC236}">
                <a16:creationId xmlns:a16="http://schemas.microsoft.com/office/drawing/2014/main" id="{9D61BA7A-54FA-7B49-3A45-1A003B72EEB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73355" y="985581"/>
            <a:ext cx="2113184" cy="2202057"/>
          </a:xfrm>
          <a:prstGeom prst="rect">
            <a:avLst/>
          </a:prstGeom>
        </p:spPr>
      </p:pic>
      <p:pic>
        <p:nvPicPr>
          <p:cNvPr id="6" name="Grafik 5" descr="Ein Bild, das Text, Screenshot, Diagramm, Schrift enthält.&#10;&#10;Automatisch generierte Beschreibung">
            <a:extLst>
              <a:ext uri="{FF2B5EF4-FFF2-40B4-BE49-F238E27FC236}">
                <a16:creationId xmlns:a16="http://schemas.microsoft.com/office/drawing/2014/main" id="{29DC31FF-3C67-5C17-7950-97E1B7A447A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144395" y="985581"/>
            <a:ext cx="2113184" cy="2212162"/>
          </a:xfrm>
          <a:prstGeom prst="rect">
            <a:avLst/>
          </a:prstGeom>
        </p:spPr>
      </p:pic>
      <p:pic>
        <p:nvPicPr>
          <p:cNvPr id="9" name="Grafik 8" descr="Ein Bild, das Text, Diagramm, Screenshot, Reihe enthält.&#10;&#10;Automatisch generierte Beschreibung">
            <a:extLst>
              <a:ext uri="{FF2B5EF4-FFF2-40B4-BE49-F238E27FC236}">
                <a16:creationId xmlns:a16="http://schemas.microsoft.com/office/drawing/2014/main" id="{2DF70D18-58A8-E259-FBA2-B638A7882E2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204620" y="3422595"/>
            <a:ext cx="2050654" cy="2212162"/>
          </a:xfrm>
          <a:prstGeom prst="rect">
            <a:avLst/>
          </a:prstGeom>
        </p:spPr>
      </p:pic>
      <p:pic>
        <p:nvPicPr>
          <p:cNvPr id="14" name="Grafik 13" descr="Ein Bild, das Text, Screenshot, Diagramm, Reihe enthält.&#10;&#10;Automatisch generierte Beschreibung">
            <a:extLst>
              <a:ext uri="{FF2B5EF4-FFF2-40B4-BE49-F238E27FC236}">
                <a16:creationId xmlns:a16="http://schemas.microsoft.com/office/drawing/2014/main" id="{E0E5CFFD-C084-7790-D91A-B403C212C4FA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255274" y="3504696"/>
            <a:ext cx="2114551" cy="2130061"/>
          </a:xfrm>
          <a:prstGeom prst="rect">
            <a:avLst/>
          </a:prstGeom>
        </p:spPr>
      </p:pic>
      <p:sp>
        <p:nvSpPr>
          <p:cNvPr id="20" name="Textfeld 19">
            <a:extLst>
              <a:ext uri="{FF2B5EF4-FFF2-40B4-BE49-F238E27FC236}">
                <a16:creationId xmlns:a16="http://schemas.microsoft.com/office/drawing/2014/main" id="{D60E17AD-9ECA-9890-0FA7-BDF48608512C}"/>
              </a:ext>
            </a:extLst>
          </p:cNvPr>
          <p:cNvSpPr txBox="1"/>
          <p:nvPr/>
        </p:nvSpPr>
        <p:spPr>
          <a:xfrm>
            <a:off x="3195432" y="3310201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173890364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Grafik 4" descr="Ein Bild, das Text, Diagramm, Screenshot, Design enthält.&#10;&#10;Automatisch generierte Beschreibung">
            <a:extLst>
              <a:ext uri="{FF2B5EF4-FFF2-40B4-BE49-F238E27FC236}">
                <a16:creationId xmlns:a16="http://schemas.microsoft.com/office/drawing/2014/main" id="{2F260524-A80A-C0E6-0007-CBD87795AA2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510" y="2896453"/>
            <a:ext cx="3567768" cy="2353499"/>
          </a:xfrm>
          <a:prstGeom prst="rect">
            <a:avLst/>
          </a:prstGeom>
        </p:spPr>
      </p:pic>
      <p:pic>
        <p:nvPicPr>
          <p:cNvPr id="7" name="Grafik 6" descr="Ein Bild, das Diagramm, Reihe, Text enthält.&#10;&#10;Automatisch generierte Beschreibung">
            <a:extLst>
              <a:ext uri="{FF2B5EF4-FFF2-40B4-BE49-F238E27FC236}">
                <a16:creationId xmlns:a16="http://schemas.microsoft.com/office/drawing/2014/main" id="{90C0BF01-762B-3825-2A0B-D60F1989D7E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1232" y="5249952"/>
            <a:ext cx="3390403" cy="2353499"/>
          </a:xfrm>
          <a:prstGeom prst="rect">
            <a:avLst/>
          </a:prstGeom>
        </p:spPr>
      </p:pic>
      <p:pic>
        <p:nvPicPr>
          <p:cNvPr id="9" name="Grafik 8" descr="Ein Bild, das Reihe, Diagramm, parallel, Steigung enthält.&#10;&#10;Automatisch generierte Beschreibung">
            <a:extLst>
              <a:ext uri="{FF2B5EF4-FFF2-40B4-BE49-F238E27FC236}">
                <a16:creationId xmlns:a16="http://schemas.microsoft.com/office/drawing/2014/main" id="{2430505D-93EE-FD2F-9649-3977B9EAEE6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488191" y="2896453"/>
            <a:ext cx="3369234" cy="2337699"/>
          </a:xfrm>
          <a:prstGeom prst="rect">
            <a:avLst/>
          </a:prstGeom>
        </p:spPr>
      </p:pic>
      <p:pic>
        <p:nvPicPr>
          <p:cNvPr id="11" name="Grafik 10" descr="Ein Bild, das Diagramm, Reihe, Plan, parallel enthält.&#10;&#10;Automatisch generierte Beschreibung">
            <a:extLst>
              <a:ext uri="{FF2B5EF4-FFF2-40B4-BE49-F238E27FC236}">
                <a16:creationId xmlns:a16="http://schemas.microsoft.com/office/drawing/2014/main" id="{75E971E8-FAFD-4249-3F8D-07239589C9D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471040" y="5221933"/>
            <a:ext cx="3390403" cy="2365718"/>
          </a:xfrm>
          <a:prstGeom prst="rect">
            <a:avLst/>
          </a:prstGeom>
        </p:spPr>
      </p:pic>
      <p:pic>
        <p:nvPicPr>
          <p:cNvPr id="13" name="Grafik 12" descr="Ein Bild, das Text, Screenshot, Design enthält.&#10;&#10;Automatisch generierte Beschreibung">
            <a:extLst>
              <a:ext uri="{FF2B5EF4-FFF2-40B4-BE49-F238E27FC236}">
                <a16:creationId xmlns:a16="http://schemas.microsoft.com/office/drawing/2014/main" id="{D32F7528-0AD5-AA8D-D3E3-ED38ECD20CB0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t="21836"/>
          <a:stretch/>
        </p:blipFill>
        <p:spPr>
          <a:xfrm>
            <a:off x="198562" y="289658"/>
            <a:ext cx="3142302" cy="2404460"/>
          </a:xfrm>
          <a:prstGeom prst="rect">
            <a:avLst/>
          </a:prstGeom>
        </p:spPr>
      </p:pic>
      <p:pic>
        <p:nvPicPr>
          <p:cNvPr id="14" name="Grafik 13" descr="Ein Bild, das Text, Screenshot, Design enthält.&#10;&#10;Automatisch generierte Beschreibung">
            <a:extLst>
              <a:ext uri="{FF2B5EF4-FFF2-40B4-BE49-F238E27FC236}">
                <a16:creationId xmlns:a16="http://schemas.microsoft.com/office/drawing/2014/main" id="{7EF18216-E146-9DA3-4934-478CFAA11E2D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39416" b="85906"/>
          <a:stretch/>
        </p:blipFill>
        <p:spPr>
          <a:xfrm>
            <a:off x="2642854" y="366109"/>
            <a:ext cx="2891171" cy="658399"/>
          </a:xfrm>
          <a:prstGeom prst="rect">
            <a:avLst/>
          </a:prstGeom>
        </p:spPr>
      </p:pic>
      <p:sp>
        <p:nvSpPr>
          <p:cNvPr id="15" name="Textfeld 14">
            <a:extLst>
              <a:ext uri="{FF2B5EF4-FFF2-40B4-BE49-F238E27FC236}">
                <a16:creationId xmlns:a16="http://schemas.microsoft.com/office/drawing/2014/main" id="{8CF49729-9F98-4B3F-C803-6EE369A2114D}"/>
              </a:ext>
            </a:extLst>
          </p:cNvPr>
          <p:cNvSpPr txBox="1"/>
          <p:nvPr/>
        </p:nvSpPr>
        <p:spPr>
          <a:xfrm>
            <a:off x="-24839" y="120381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16" name="Textfeld 15">
            <a:extLst>
              <a:ext uri="{FF2B5EF4-FFF2-40B4-BE49-F238E27FC236}">
                <a16:creationId xmlns:a16="http://schemas.microsoft.com/office/drawing/2014/main" id="{DEA291C3-B039-B189-70E1-F14171911C8C}"/>
              </a:ext>
            </a:extLst>
          </p:cNvPr>
          <p:cNvSpPr txBox="1"/>
          <p:nvPr/>
        </p:nvSpPr>
        <p:spPr>
          <a:xfrm>
            <a:off x="-47153" y="2674803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17" name="Textfeld 16">
            <a:extLst>
              <a:ext uri="{FF2B5EF4-FFF2-40B4-BE49-F238E27FC236}">
                <a16:creationId xmlns:a16="http://schemas.microsoft.com/office/drawing/2014/main" id="{CEDF2E5C-3F1E-F1CB-19FB-4264EE1398DD}"/>
              </a:ext>
            </a:extLst>
          </p:cNvPr>
          <p:cNvSpPr txBox="1"/>
          <p:nvPr/>
        </p:nvSpPr>
        <p:spPr>
          <a:xfrm>
            <a:off x="-32211" y="5108694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</a:p>
        </p:txBody>
      </p:sp>
      <p:sp>
        <p:nvSpPr>
          <p:cNvPr id="18" name="Textfeld 17">
            <a:extLst>
              <a:ext uri="{FF2B5EF4-FFF2-40B4-BE49-F238E27FC236}">
                <a16:creationId xmlns:a16="http://schemas.microsoft.com/office/drawing/2014/main" id="{28F49F13-D83D-89F1-4D71-CFD53E279C03}"/>
              </a:ext>
            </a:extLst>
          </p:cNvPr>
          <p:cNvSpPr txBox="1"/>
          <p:nvPr/>
        </p:nvSpPr>
        <p:spPr>
          <a:xfrm>
            <a:off x="3384156" y="5066666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</a:p>
        </p:txBody>
      </p:sp>
      <p:sp>
        <p:nvSpPr>
          <p:cNvPr id="19" name="Textfeld 18">
            <a:extLst>
              <a:ext uri="{FF2B5EF4-FFF2-40B4-BE49-F238E27FC236}">
                <a16:creationId xmlns:a16="http://schemas.microsoft.com/office/drawing/2014/main" id="{57BEF777-79A8-EB7F-C6B1-328B097A9BBE}"/>
              </a:ext>
            </a:extLst>
          </p:cNvPr>
          <p:cNvSpPr txBox="1"/>
          <p:nvPr/>
        </p:nvSpPr>
        <p:spPr>
          <a:xfrm>
            <a:off x="3378546" y="2719608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20" name="Textfeld 19">
            <a:extLst>
              <a:ext uri="{FF2B5EF4-FFF2-40B4-BE49-F238E27FC236}">
                <a16:creationId xmlns:a16="http://schemas.microsoft.com/office/drawing/2014/main" id="{EB9E2E96-8641-DD7F-752E-BA594323FC39}"/>
              </a:ext>
            </a:extLst>
          </p:cNvPr>
          <p:cNvSpPr txBox="1"/>
          <p:nvPr/>
        </p:nvSpPr>
        <p:spPr>
          <a:xfrm>
            <a:off x="395273" y="7728909"/>
            <a:ext cx="6067453" cy="19214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15000"/>
              </a:lnSpc>
            </a:pPr>
            <a:r>
              <a:rPr lang="en-GB" sz="800" b="1" dirty="0"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Supplemental Figure 2: Cellular response to UV-irradiation in lymphoblastoid cell lines (LCLs) of heterozygous carriers (parents of patient 1).</a:t>
            </a:r>
            <a:endParaRPr lang="de-AT" sz="800" dirty="0"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lnSpc>
                <a:spcPct val="115000"/>
              </a:lnSpc>
            </a:pPr>
            <a:r>
              <a:rPr lang="en-GB" sz="800" b="1" dirty="0"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A</a:t>
            </a:r>
            <a:r>
              <a:rPr lang="en-GB" sz="800" dirty="0"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Proliferation capacity of UV-irradiated LCLs. Non-irradiated control cells served as reference for calculation of proliferation activity in each sample (proliferation activity measured in disintegrations per minute (DPM)). LCL cultures were UV-irradiated and thymidine-[methyl-3H] was added directly after (1</a:t>
            </a:r>
            <a:r>
              <a:rPr lang="en-GB" sz="8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st</a:t>
            </a:r>
            <a:r>
              <a:rPr lang="en-GB" sz="800" dirty="0"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day) and 24 hours (2nd day) later. Cells were then incubated for 24 hours to investigate proliferation. Relative values represent proliferation capacity following UV-irradiation. Individual values from HCs are shown as rings and bars indicate mean. </a:t>
            </a:r>
            <a:r>
              <a:rPr lang="en-GB" sz="8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Heterozygous carriers</a:t>
            </a:r>
            <a:r>
              <a:rPr lang="en-GB" sz="800" dirty="0"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are shown in green symbols (bullet=mother, square=father). Error bars show standard deviations from the mean (3 experiments). </a:t>
            </a:r>
            <a:r>
              <a:rPr lang="en-GB" sz="800" b="1" dirty="0"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B-E</a:t>
            </a:r>
            <a:r>
              <a:rPr lang="en-GB" sz="800" dirty="0"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Viability following UV-irradiation in LCLs. Intracellular signals of </a:t>
            </a:r>
            <a:r>
              <a:rPr lang="en-GB" sz="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  <a:sym typeface="Symbol" pitchFamily="2" charset="2"/>
              </a:rPr>
              <a:t></a:t>
            </a:r>
            <a:r>
              <a:rPr lang="en-GB" sz="800" dirty="0"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-H2AX (</a:t>
            </a:r>
            <a:r>
              <a:rPr lang="en-GB" sz="800" b="1" dirty="0"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B</a:t>
            </a:r>
            <a:r>
              <a:rPr lang="en-GB" sz="800" dirty="0"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, DNA damage), active caspase-3 (</a:t>
            </a:r>
            <a:r>
              <a:rPr lang="en-GB" sz="800" b="1" dirty="0"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C</a:t>
            </a:r>
            <a:r>
              <a:rPr lang="en-GB" sz="800" dirty="0"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, apoptotic cells) and viability dye (</a:t>
            </a:r>
            <a:r>
              <a:rPr lang="en-GB" sz="800" b="1" dirty="0"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D</a:t>
            </a:r>
            <a:r>
              <a:rPr lang="en-GB" sz="800" dirty="0"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, necrotic cells) were evaluated by intracellular multicolour flow-cytometry analysis following UV-irradiation and recovery. Mean fluorescence intensities (MFI) represent </a:t>
            </a:r>
            <a:r>
              <a:rPr lang="en-GB" sz="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  <a:sym typeface="Symbol" pitchFamily="2" charset="2"/>
              </a:rPr>
              <a:t></a:t>
            </a:r>
            <a:r>
              <a:rPr lang="en-GB" sz="800" dirty="0"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-H2AX levels. Percentage apoptotic cells represent amount of active-caspase-3 positive cells in the culture and percentage necrotic cells were identified by increased levels of intracellular signals of viability dye. Percentage viable cells (</a:t>
            </a:r>
            <a:r>
              <a:rPr lang="en-GB" sz="800" b="1" dirty="0"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E</a:t>
            </a:r>
            <a:r>
              <a:rPr lang="en-GB" sz="800" dirty="0"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) represent the sum of non-apoptotic and non-necrotic cells in each UV-irradiated cell culture. Non-UV-irradiated cells from each tested individual served as untreated controls (data not shown). </a:t>
            </a:r>
            <a:endParaRPr lang="de-AT" sz="800" dirty="0"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920008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508</Words>
  <Application>Microsoft Macintosh PowerPoint</Application>
  <PresentationFormat>A4-Papier (210 x 297 mm)</PresentationFormat>
  <Paragraphs>13</Paragraphs>
  <Slides>2</Slides>
  <Notes>1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</vt:lpstr>
      <vt:lpstr>PowerPoint-Präsentation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Rossmanith, Raphael</dc:creator>
  <cp:lastModifiedBy>Raphael Rossmanith</cp:lastModifiedBy>
  <cp:revision>117</cp:revision>
  <cp:lastPrinted>2023-03-14T14:36:49Z</cp:lastPrinted>
  <dcterms:created xsi:type="dcterms:W3CDTF">2022-08-02T12:16:15Z</dcterms:created>
  <dcterms:modified xsi:type="dcterms:W3CDTF">2024-06-21T20:29:13Z</dcterms:modified>
</cp:coreProperties>
</file>